
<file path=[Content_Types].xml><?xml version="1.0" encoding="utf-8"?>
<Types xmlns="http://schemas.openxmlformats.org/package/2006/content-types">
  <Default ContentType="image/jpeg" Extension="jpg"/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1.xml"/>
  <Override ContentType="application/vnd.openxmlformats-officedocument.presentationml.slide+xml" PartName="/ppt/slides/slide1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2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8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7" Type="http://schemas.openxmlformats.org/officeDocument/2006/relationships/slide" Target="slides/slide12.xml"/><Relationship Id="rId16" Type="http://schemas.openxmlformats.org/officeDocument/2006/relationships/slide" Target="slides/slide1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18" Type="http://schemas.openxmlformats.org/officeDocument/2006/relationships/slide" Target="slides/slide13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363b5fc70a3_0_1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363b5fc70a3_0_1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4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g363b5fc70a3_0_3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6" name="Google Shape;106;g363b5fc70a3_0_3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0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g363b5fc70a3_0_3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2" name="Google Shape;112;g363b5fc70a3_0_3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6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g363b5fc70a3_0_42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8" name="Google Shape;118;g363b5fc70a3_0_4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2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g363b5fc70a3_0_12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4" name="Google Shape;124;g363b5fc70a3_0_1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p:notes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2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363b5fc70a3_0_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363b5fc70a3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363b5fc70a3_0_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363b5fc70a3_0_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363b5fc70a3_0_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363b5fc70a3_0_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363b5fc70a3_0_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363b5fc70a3_0_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6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g363b5fc70a3_0_2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8" name="Google Shape;88;g363b5fc70a3_0_2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2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g363b5fc70a3_0_3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4" name="Google Shape;94;g363b5fc70a3_0_3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8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363b5fc70a3_0_3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0" name="Google Shape;100;g363b5fc70a3_0_3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5.jpg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8.jp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0.jp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3.jp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2.jp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1.jp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.jp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2.jp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4.jp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3.jp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9.jp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6.jp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 title="Гель 1.2 (1,2,4,17) ОК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Google Shape;55;p13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s 1, 2, 4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7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Google Shape;108;p22" title="Гель 10 (12,34,35) OK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109" name="Google Shape;109;p22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12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3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Google Shape;114;p23" title="45,52,53,54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9788" y="304800"/>
            <a:ext cx="6444416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115" name="Google Shape;115;p23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13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9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Google Shape;120;p24" title="45,55,56,57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9788" y="304800"/>
            <a:ext cx="6444416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121" name="Google Shape;121;p24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13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5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Google Shape;126;p25" title="Гель 13 (14,41) ОК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127" name="Google Shape;127;p25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14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oogle Shape;60;p14" title="42,46,47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9788" y="304800"/>
            <a:ext cx="6444416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61" name="Google Shape;61;p14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3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Google Shape;66;p15" title="43,48,49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9788" y="304800"/>
            <a:ext cx="6444416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67" name="Google Shape;67;p15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5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Google Shape;72;p16" title="Гель 4 (6,20,21,22) ОК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73" name="Google Shape;73;p16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6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7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Google Shape;78;p17" title="Гель 5 (7,23,24) ОК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79" name="Google Shape;79;p17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7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8" title="Гель 6 (7,25,26) OK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8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7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9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19" title="Гель 7 (8,27,11,33) OK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19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s 8, 11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5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Google Shape;96;p20" title="Гель 8 (9,28,29,39) OK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97" name="Google Shape;97;p20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9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Google Shape;102;p21" title="Гель 9 (10,31,32) OK.jp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46200" y="304800"/>
            <a:ext cx="6451600" cy="4838700"/>
          </a:xfrm>
          <a:prstGeom prst="rect">
            <a:avLst/>
          </a:prstGeom>
          <a:noFill/>
          <a:ln>
            <a:noFill/>
          </a:ln>
        </p:spPr>
      </p:pic>
      <p:sp>
        <p:nvSpPr>
          <p:cNvPr id="103" name="Google Shape;103;p21"/>
          <p:cNvSpPr txBox="1"/>
          <p:nvPr/>
        </p:nvSpPr>
        <p:spPr>
          <a:xfrm>
            <a:off x="0" y="0"/>
            <a:ext cx="4667700" cy="304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ru" sz="1800">
                <a:solidFill>
                  <a:schemeClr val="dk2"/>
                </a:solidFill>
              </a:rPr>
              <a:t>Exon 10</a:t>
            </a:r>
            <a:endParaRPr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